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6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2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6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80734541838022E-2"/>
          <c:y val="2.3609741947257821E-2"/>
          <c:w val="0.93821655445243257"/>
          <c:h val="0.8386212854263676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ntrol group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7</c:f>
              <c:numCache>
                <c:formatCode>General</c:formatCode>
                <c:ptCount val="6"/>
                <c:pt idx="0">
                  <c:v>-66</c:v>
                </c:pt>
                <c:pt idx="1">
                  <c:v>-1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</c:numCache>
            </c:numRef>
          </c:cat>
          <c:val>
            <c:numRef>
              <c:f>Sheet1!$B$2:$B$7</c:f>
              <c:numCache>
                <c:formatCode>General</c:formatCode>
                <c:ptCount val="6"/>
                <c:pt idx="0">
                  <c:v>0.11700000000000001</c:v>
                </c:pt>
                <c:pt idx="1">
                  <c:v>0.68899999999999995</c:v>
                </c:pt>
                <c:pt idx="2">
                  <c:v>0.70799999999999996</c:v>
                </c:pt>
                <c:pt idx="3">
                  <c:v>0.75900000000000001</c:v>
                </c:pt>
                <c:pt idx="4">
                  <c:v>0.88900000000000001</c:v>
                </c:pt>
                <c:pt idx="5">
                  <c:v>0.805000000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920-45FC-819E-829D2371CDE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VP (moxidectin 0.025 mg/kg)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prstDash val="sysDash"/>
              <a:round/>
            </a:ln>
            <a:effectLst/>
          </c:spPr>
          <c:marker>
            <c:symbol val="triangle"/>
            <c:size val="12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7</c:f>
              <c:numCache>
                <c:formatCode>General</c:formatCode>
                <c:ptCount val="6"/>
                <c:pt idx="0">
                  <c:v>-66</c:v>
                </c:pt>
                <c:pt idx="1">
                  <c:v>-1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</c:numCache>
            </c:numRef>
          </c:cat>
          <c:val>
            <c:numRef>
              <c:f>Sheet1!$C$2:$C$7</c:f>
              <c:numCache>
                <c:formatCode>General</c:formatCode>
                <c:ptCount val="6"/>
                <c:pt idx="0">
                  <c:v>0.11700000000000001</c:v>
                </c:pt>
                <c:pt idx="1">
                  <c:v>0.64200000000000002</c:v>
                </c:pt>
                <c:pt idx="2">
                  <c:v>0.70099999999999996</c:v>
                </c:pt>
                <c:pt idx="3">
                  <c:v>0.67</c:v>
                </c:pt>
                <c:pt idx="4">
                  <c:v>0.752</c:v>
                </c:pt>
                <c:pt idx="5">
                  <c:v>0.587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920-45FC-819E-829D2371CD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09921840"/>
        <c:axId val="1109942000"/>
      </c:lineChart>
      <c:catAx>
        <c:axId val="1109921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09942000"/>
        <c:crosses val="autoZero"/>
        <c:auto val="1"/>
        <c:lblAlgn val="ctr"/>
        <c:lblOffset val="100"/>
        <c:noMultiLvlLbl val="0"/>
      </c:catAx>
      <c:valAx>
        <c:axId val="110994200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099218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9.2747037644266936E-2"/>
          <c:y val="2.0718492916519567E-3"/>
          <c:w val="0.66099920731883144"/>
          <c:h val="0.123476734928726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0774943892882956E-2"/>
          <c:y val="2.3609727679778047E-2"/>
          <c:w val="0.93821655445243257"/>
          <c:h val="0.83052451305803776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ntrol group</c:v>
                </c:pt>
              </c:strCache>
            </c:strRef>
          </c:tx>
          <c:spPr>
            <a:ln w="5080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7</c:f>
              <c:numCache>
                <c:formatCode>General</c:formatCode>
                <c:ptCount val="6"/>
                <c:pt idx="0">
                  <c:v>-66</c:v>
                </c:pt>
                <c:pt idx="1">
                  <c:v>-1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</c:numCache>
            </c:numRef>
          </c:cat>
          <c:val>
            <c:numRef>
              <c:f>Sheet1!$B$2:$B$7</c:f>
              <c:numCache>
                <c:formatCode>General</c:formatCode>
                <c:ptCount val="6"/>
                <c:pt idx="0">
                  <c:v>5.8999999999999997E-2</c:v>
                </c:pt>
                <c:pt idx="1">
                  <c:v>0.65</c:v>
                </c:pt>
                <c:pt idx="2">
                  <c:v>0.82699999999999996</c:v>
                </c:pt>
                <c:pt idx="3">
                  <c:v>0.878</c:v>
                </c:pt>
                <c:pt idx="4">
                  <c:v>1.079</c:v>
                </c:pt>
                <c:pt idx="5">
                  <c:v>1.042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737-42BF-B000-3F8740A94F62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oxidecting 0.0125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2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7</c:f>
              <c:numCache>
                <c:formatCode>General</c:formatCode>
                <c:ptCount val="6"/>
                <c:pt idx="0">
                  <c:v>-66</c:v>
                </c:pt>
                <c:pt idx="1">
                  <c:v>-1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</c:numCache>
            </c:numRef>
          </c:cat>
          <c:val>
            <c:numRef>
              <c:f>Sheet1!$C$2:$C$7</c:f>
              <c:numCache>
                <c:formatCode>General</c:formatCode>
                <c:ptCount val="6"/>
                <c:pt idx="0">
                  <c:v>6.6000000000000003E-2</c:v>
                </c:pt>
                <c:pt idx="1">
                  <c:v>0.60199999999999998</c:v>
                </c:pt>
                <c:pt idx="2">
                  <c:v>0.54900000000000004</c:v>
                </c:pt>
                <c:pt idx="3">
                  <c:v>0.307</c:v>
                </c:pt>
                <c:pt idx="4">
                  <c:v>0.185</c:v>
                </c:pt>
                <c:pt idx="5">
                  <c:v>0.1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737-42BF-B000-3F8740A94F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09921840"/>
        <c:axId val="1109942000"/>
      </c:lineChart>
      <c:catAx>
        <c:axId val="1109921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09942000"/>
        <c:crosses val="autoZero"/>
        <c:auto val="1"/>
        <c:lblAlgn val="ctr"/>
        <c:lblOffset val="100"/>
        <c:noMultiLvlLbl val="0"/>
      </c:catAx>
      <c:valAx>
        <c:axId val="110994200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099218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E62E06-658A-40CC-B360-3CDB8600CBEB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624DBF-FD70-4C22-BDD0-F0E5F36983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0571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624DBF-FD70-4C22-BDD0-F0E5F369838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2374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DA517-0F20-858C-3BCE-11620894B8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2EA6C4-F5F0-6EBA-45AD-35D5BAC098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4EB729-7592-5225-494D-209BC0B4F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BC203E-7C10-4134-F0B6-0C26D1788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78DF2A-DF80-3C82-079E-F4039509D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870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4CE29A-8DE9-AAC1-B300-E1CF978FE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C68EB6-37C9-B948-E2A7-BF90644817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FA4EA2-A060-86AA-691B-44B81848F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1BEC7B-5DD8-0D29-7C69-CA72D4837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BB2A56-9D84-837A-70F0-C4FFB983A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57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AD62AD-66B6-6877-991B-FF98B4EE8E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235F1F-E386-1600-9B1F-570AC722AC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1B3F8D-507C-8D64-4775-AA524501E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A43B64-24A0-FC2E-BDE2-386DA3CA9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3D4D77-F05D-35B4-99B6-4EFC024B8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331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3EF78B-FD69-AC3E-CC48-23E28CEA9A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220E8B-559F-2FC5-A52F-45C58221A2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D3174B-216A-DAA4-D750-867A00AB9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C63557-6C86-42E2-7F55-1E46FF10E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091403-4410-3459-3DF0-22E9654BC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282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002AF-6613-FDCC-7076-9CAD10FD1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0B9EC0-FC2C-AA8E-3062-69E148DF90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A5797F-D735-F9ED-8AD7-6A830FAB4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6FBE9B-124B-CCB7-4D82-A232DDC70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799336-6543-3C01-64CA-7F4B85412B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687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212E9-3289-6EA5-2141-472CC8098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5E00AB-ACB1-BF5B-1B8A-4170242D5E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501BD-48E9-AC4E-7049-EA76F3901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163A8C-5EE1-20F0-E1F5-DE200CB92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603EB8-6A24-16AB-DB6D-9BC90CBB2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C8360E-ED3C-BC9C-70AE-356897F00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25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3F8482-E52E-ED81-73E6-7C4C2C44D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6B69A1-EBE0-819A-5D2B-0AEAB523BB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3F79A1-E915-AEAB-281E-1E8716AE8D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FECEF9-71B4-72A4-9F16-70F640024A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894E78-A6B2-BF53-D8D7-5565181C06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11889C-EA61-A039-8E6C-B05667531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F55636-38F1-652B-1937-76F5A1D5F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CB0A7F-2C94-EFAE-6F08-3BCB0B92F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043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34FBB3-3543-696A-5AFF-DDC8522178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C16EA9-6A3D-8C25-0C01-3769AF611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78DEE70-1697-2AB3-5794-7C71C330F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085DAD-61F6-7D15-3238-A70BFBC61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504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4913DA0-3165-9E27-55C9-2AD359F73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1D9B7C3-07FC-0AFA-8A1C-EF25F2A73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13BD488-6CB5-7117-4285-5DFA8EB7D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045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833169-5791-6FC6-14DB-A66DD9DFE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1592D4-AA15-209F-1E85-B1BD579F31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B544A2-8961-14BA-0C0D-043B1A5986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9084E7-97E7-0C80-C802-83AAB2256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090153-B8B2-744C-C7E8-5B9D9136A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800B43-A36A-4632-172C-E61D5C659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38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1205BB-BB7B-EB85-468F-EA98CBB37C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8CAAA8-2782-2BFC-DD73-6B47395910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9BD6C3-FC3D-005A-025D-947CF92A2E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45E298-4842-DE87-026B-EF84BBF7B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3F4A63-5FE3-0764-44BF-681006121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9F4AE1-0D09-97AA-277A-69D7A48D3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001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AF187D-125E-BA74-054A-7A7489DECE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619784-7B53-F3B0-F1FD-9A62C1C4E1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B7E9C1-41DB-F6FA-D594-1B3C659691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747F28-5289-4147-B8E4-7C3926D95DCE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8BA8D3-AFA9-4088-EB72-6EC8DB8487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846CDC-2439-3227-FB44-73655BE461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944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284DA89-2ADE-C92A-F565-C24C3FE3C0A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25AE1E08-E054-A8A4-242F-70315FF3EF3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950653516"/>
              </p:ext>
            </p:extLst>
          </p:nvPr>
        </p:nvGraphicFramePr>
        <p:xfrm>
          <a:off x="588764" y="569631"/>
          <a:ext cx="5687028" cy="62741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0F0E1EF0-1AD1-1931-79D1-08A098E4103E}"/>
              </a:ext>
            </a:extLst>
          </p:cNvPr>
          <p:cNvSpPr txBox="1"/>
          <p:nvPr/>
        </p:nvSpPr>
        <p:spPr>
          <a:xfrm>
            <a:off x="1714551" y="6443939"/>
            <a:ext cx="285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udy da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9C30140-42AA-F1D0-1A0B-118F5DD28A62}"/>
              </a:ext>
            </a:extLst>
          </p:cNvPr>
          <p:cNvSpPr txBox="1"/>
          <p:nvPr/>
        </p:nvSpPr>
        <p:spPr>
          <a:xfrm>
            <a:off x="-148959" y="5375"/>
            <a:ext cx="30047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. Mean antibody level</a:t>
            </a:r>
          </a:p>
        </p:txBody>
      </p:sp>
      <p:graphicFrame>
        <p:nvGraphicFramePr>
          <p:cNvPr id="2" name="Content Placeholder 5">
            <a:extLst>
              <a:ext uri="{FF2B5EF4-FFF2-40B4-BE49-F238E27FC236}">
                <a16:creationId xmlns:a16="http://schemas.microsoft.com/office/drawing/2014/main" id="{85FBC53C-3E88-DC8F-BD04-E9806B83BA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4169838"/>
              </p:ext>
            </p:extLst>
          </p:nvPr>
        </p:nvGraphicFramePr>
        <p:xfrm>
          <a:off x="6275792" y="583894"/>
          <a:ext cx="5916208" cy="62741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137A5D1E-799B-CC71-62CD-DAC196C07DD4}"/>
              </a:ext>
            </a:extLst>
          </p:cNvPr>
          <p:cNvSpPr txBox="1"/>
          <p:nvPr/>
        </p:nvSpPr>
        <p:spPr>
          <a:xfrm>
            <a:off x="6096000" y="0"/>
            <a:ext cx="29379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. Mean antigen leve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7B17527-8A2A-1EE8-973E-F908992E6C15}"/>
              </a:ext>
            </a:extLst>
          </p:cNvPr>
          <p:cNvSpPr txBox="1"/>
          <p:nvPr/>
        </p:nvSpPr>
        <p:spPr>
          <a:xfrm>
            <a:off x="7871361" y="6443939"/>
            <a:ext cx="285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udy day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B6F4D4E-F8C1-D6A8-E857-8857A117403B}"/>
              </a:ext>
            </a:extLst>
          </p:cNvPr>
          <p:cNvSpPr txBox="1"/>
          <p:nvPr/>
        </p:nvSpPr>
        <p:spPr>
          <a:xfrm rot="16200000">
            <a:off x="-1435621" y="2705362"/>
            <a:ext cx="3478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ptical density values</a:t>
            </a:r>
          </a:p>
        </p:txBody>
      </p:sp>
    </p:spTree>
    <p:extLst>
      <p:ext uri="{BB962C8B-B14F-4D97-AF65-F5344CB8AC3E}">
        <p14:creationId xmlns:p14="http://schemas.microsoft.com/office/powerpoint/2010/main" val="846086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Sensitivity_x0020_Classification xmlns="3d11f5f8-be67-4542-bead-b3c32360da4c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1A3A1D3EF3E234B88CFE3C36572E007" ma:contentTypeVersion="16" ma:contentTypeDescription="Create a new document." ma:contentTypeScope="" ma:versionID="b0e94ee56493728b36f9422c50d28421">
  <xsd:schema xmlns:xsd="http://www.w3.org/2001/XMLSchema" xmlns:xs="http://www.w3.org/2001/XMLSchema" xmlns:p="http://schemas.microsoft.com/office/2006/metadata/properties" xmlns:ns2="3d11f5f8-be67-4542-bead-b3c32360da4c" xmlns:ns3="1fe888d8-3969-4b7a-aa21-a80028d9b940" xmlns:ns4="152a24a1-2573-4865-8574-285e3208fcc6" targetNamespace="http://schemas.microsoft.com/office/2006/metadata/properties" ma:root="true" ma:fieldsID="3bdc5ac65f597991cdff7786828e1921" ns2:_="" ns3:_="" ns4:_="">
    <xsd:import namespace="3d11f5f8-be67-4542-bead-b3c32360da4c"/>
    <xsd:import namespace="1fe888d8-3969-4b7a-aa21-a80028d9b940"/>
    <xsd:import namespace="152a24a1-2573-4865-8574-285e3208fcc6"/>
    <xsd:element name="properties">
      <xsd:complexType>
        <xsd:sequence>
          <xsd:element name="documentManagement">
            <xsd:complexType>
              <xsd:all>
                <xsd:element ref="ns2:Sensitivity_x0020_Classification"/>
                <xsd:element ref="ns3:SharedWithUsers" minOccurs="0"/>
                <xsd:element ref="ns4:MediaServiceMetadata" minOccurs="0"/>
                <xsd:element ref="ns4:MediaServiceFastMetadata" minOccurs="0"/>
                <xsd:element ref="ns4:MediaServiceSearchProperties" minOccurs="0"/>
                <xsd:element ref="ns4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d11f5f8-be67-4542-bead-b3c32360da4c" elementFormDefault="qualified">
    <xsd:import namespace="http://schemas.microsoft.com/office/2006/documentManagement/types"/>
    <xsd:import namespace="http://schemas.microsoft.com/office/infopath/2007/PartnerControls"/>
    <xsd:element name="Sensitivity_x0020_Classification" ma:index="8" ma:displayName="Sensitivity Classification" ma:internalName="Sensitivity_x0020_Classification" ma:readOnly="false">
      <xsd:simpleType>
        <xsd:restriction base="dms:Choice">
          <xsd:enumeration value="Sensitive (highest)"/>
          <xsd:enumeration value="Confidential"/>
          <xsd:enumeration value="Proprietary"/>
          <xsd:enumeration value="Public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e888d8-3969-4b7a-aa21-a80028d9b940" elementFormDefault="qualified">
    <xsd:import namespace="http://schemas.microsoft.com/office/2006/documentManagement/types"/>
    <xsd:import namespace="http://schemas.microsoft.com/office/infopath/2007/PartnerControls"/>
    <xsd:element name="SharedWithUsers" ma:index="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52a24a1-2573-4865-8574-285e3208fcc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29EB82A-4827-4406-84FD-4876F19B6837}">
  <ds:schemaRefs>
    <ds:schemaRef ds:uri="http://schemas.microsoft.com/office/2006/metadata/properties"/>
    <ds:schemaRef ds:uri="http://schemas.microsoft.com/office/infopath/2007/PartnerControls"/>
    <ds:schemaRef ds:uri="3d11f5f8-be67-4542-bead-b3c32360da4c"/>
  </ds:schemaRefs>
</ds:datastoreItem>
</file>

<file path=customXml/itemProps2.xml><?xml version="1.0" encoding="utf-8"?>
<ds:datastoreItem xmlns:ds="http://schemas.openxmlformats.org/officeDocument/2006/customXml" ds:itemID="{17A09280-4843-408B-A7B6-9CBA76B9158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0B1484B-94A1-4B52-8370-CE466620431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d11f5f8-be67-4542-bead-b3c32360da4c"/>
    <ds:schemaRef ds:uri="1fe888d8-3969-4b7a-aa21-a80028d9b940"/>
    <ds:schemaRef ds:uri="152a24a1-2573-4865-8574-285e3208fcc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290</TotalTime>
  <Words>18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illiam Ryan</dc:creator>
  <cp:lastModifiedBy>William Ryan</cp:lastModifiedBy>
  <cp:revision>22</cp:revision>
  <dcterms:created xsi:type="dcterms:W3CDTF">2025-02-06T14:07:39Z</dcterms:created>
  <dcterms:modified xsi:type="dcterms:W3CDTF">2026-04-23T15:32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1A3A1D3EF3E234B88CFE3C36572E007</vt:lpwstr>
  </property>
</Properties>
</file>